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19" r:id="rId2"/>
  </p:sldIdLst>
  <p:sldSz cx="16200438" cy="28800425"/>
  <p:notesSz cx="6805613" cy="9939338"/>
  <p:defaultTextStyle>
    <a:defPPr>
      <a:defRPr lang="ja-JP"/>
    </a:defPPr>
    <a:lvl1pPr marL="0" algn="l" defTabSz="2365134" rtl="0" eaLnBrk="1" latinLnBrk="0" hangingPunct="1">
      <a:defRPr kumimoji="1" sz="4700" kern="1200">
        <a:solidFill>
          <a:schemeClr val="tx1"/>
        </a:solidFill>
        <a:latin typeface="+mn-lt"/>
        <a:ea typeface="+mn-ea"/>
        <a:cs typeface="+mn-cs"/>
      </a:defRPr>
    </a:lvl1pPr>
    <a:lvl2pPr marL="1182567" algn="l" defTabSz="2365134" rtl="0" eaLnBrk="1" latinLnBrk="0" hangingPunct="1">
      <a:defRPr kumimoji="1" sz="4700" kern="1200">
        <a:solidFill>
          <a:schemeClr val="tx1"/>
        </a:solidFill>
        <a:latin typeface="+mn-lt"/>
        <a:ea typeface="+mn-ea"/>
        <a:cs typeface="+mn-cs"/>
      </a:defRPr>
    </a:lvl2pPr>
    <a:lvl3pPr marL="2365134" algn="l" defTabSz="2365134" rtl="0" eaLnBrk="1" latinLnBrk="0" hangingPunct="1">
      <a:defRPr kumimoji="1" sz="4700" kern="1200">
        <a:solidFill>
          <a:schemeClr val="tx1"/>
        </a:solidFill>
        <a:latin typeface="+mn-lt"/>
        <a:ea typeface="+mn-ea"/>
        <a:cs typeface="+mn-cs"/>
      </a:defRPr>
    </a:lvl3pPr>
    <a:lvl4pPr marL="3547700" algn="l" defTabSz="2365134" rtl="0" eaLnBrk="1" latinLnBrk="0" hangingPunct="1">
      <a:defRPr kumimoji="1" sz="4700" kern="1200">
        <a:solidFill>
          <a:schemeClr val="tx1"/>
        </a:solidFill>
        <a:latin typeface="+mn-lt"/>
        <a:ea typeface="+mn-ea"/>
        <a:cs typeface="+mn-cs"/>
      </a:defRPr>
    </a:lvl4pPr>
    <a:lvl5pPr marL="4730267" algn="l" defTabSz="2365134" rtl="0" eaLnBrk="1" latinLnBrk="0" hangingPunct="1">
      <a:defRPr kumimoji="1" sz="4700" kern="1200">
        <a:solidFill>
          <a:schemeClr val="tx1"/>
        </a:solidFill>
        <a:latin typeface="+mn-lt"/>
        <a:ea typeface="+mn-ea"/>
        <a:cs typeface="+mn-cs"/>
      </a:defRPr>
    </a:lvl5pPr>
    <a:lvl6pPr marL="5912832" algn="l" defTabSz="2365134" rtl="0" eaLnBrk="1" latinLnBrk="0" hangingPunct="1">
      <a:defRPr kumimoji="1" sz="4700" kern="1200">
        <a:solidFill>
          <a:schemeClr val="tx1"/>
        </a:solidFill>
        <a:latin typeface="+mn-lt"/>
        <a:ea typeface="+mn-ea"/>
        <a:cs typeface="+mn-cs"/>
      </a:defRPr>
    </a:lvl6pPr>
    <a:lvl7pPr marL="7095399" algn="l" defTabSz="2365134" rtl="0" eaLnBrk="1" latinLnBrk="0" hangingPunct="1">
      <a:defRPr kumimoji="1" sz="4700" kern="1200">
        <a:solidFill>
          <a:schemeClr val="tx1"/>
        </a:solidFill>
        <a:latin typeface="+mn-lt"/>
        <a:ea typeface="+mn-ea"/>
        <a:cs typeface="+mn-cs"/>
      </a:defRPr>
    </a:lvl7pPr>
    <a:lvl8pPr marL="8277967" algn="l" defTabSz="2365134" rtl="0" eaLnBrk="1" latinLnBrk="0" hangingPunct="1">
      <a:defRPr kumimoji="1" sz="4700" kern="1200">
        <a:solidFill>
          <a:schemeClr val="tx1"/>
        </a:solidFill>
        <a:latin typeface="+mn-lt"/>
        <a:ea typeface="+mn-ea"/>
        <a:cs typeface="+mn-cs"/>
      </a:defRPr>
    </a:lvl8pPr>
    <a:lvl9pPr marL="9460533" algn="l" defTabSz="2365134" rtl="0" eaLnBrk="1" latinLnBrk="0" hangingPunct="1">
      <a:defRPr kumimoji="1" sz="47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268" userDrawn="1">
          <p15:clr>
            <a:srgbClr val="A4A3A4"/>
          </p15:clr>
        </p15:guide>
        <p15:guide id="3" orient="horz" pos="9071" userDrawn="1">
          <p15:clr>
            <a:srgbClr val="A4A3A4"/>
          </p15:clr>
        </p15:guide>
        <p15:guide id="4" pos="5103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itoushinichirou" initials="i" lastIdx="2" clrIdx="0">
    <p:extLst>
      <p:ext uri="{19B8F6BF-5375-455C-9EA6-DF929625EA0E}">
        <p15:presenceInfo xmlns:p15="http://schemas.microsoft.com/office/powerpoint/2012/main" userId="itoushinichirou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CCFF"/>
    <a:srgbClr val="FFFF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D7AC3CCA-C797-4891-BE02-D94E43425B78}" styleName="スタイル (中間)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555" autoAdjust="0"/>
    <p:restoredTop sz="96327" autoAdjust="0"/>
  </p:normalViewPr>
  <p:slideViewPr>
    <p:cSldViewPr>
      <p:cViewPr varScale="1">
        <p:scale>
          <a:sx n="29" d="100"/>
          <a:sy n="29" d="100"/>
        </p:scale>
        <p:origin x="4480" y="312"/>
      </p:cViewPr>
      <p:guideLst>
        <p:guide orient="horz" pos="2268"/>
        <p:guide orient="horz" pos="9071"/>
        <p:guide pos="5103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30" d="100"/>
        <a:sy n="30" d="100"/>
      </p:scale>
      <p:origin x="0" y="0"/>
    </p:cViewPr>
  </p:sorterViewPr>
  <p:gridSpacing cx="180000" cy="1800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7" y="0"/>
            <a:ext cx="2949100" cy="496967"/>
          </a:xfrm>
          <a:prstGeom prst="rect">
            <a:avLst/>
          </a:prstGeom>
        </p:spPr>
        <p:txBody>
          <a:bodyPr vert="horz" lIns="92099" tIns="46051" rIns="92099" bIns="46051" rtlCol="0"/>
          <a:lstStyle>
            <a:lvl1pPr algn="l">
              <a:defRPr sz="1200"/>
            </a:lvl1pPr>
          </a:lstStyle>
          <a:p>
            <a:endParaRPr kumimoji="1" lang="ja-JP" altLang="en-US" dirty="0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54946" y="0"/>
            <a:ext cx="2949100" cy="496967"/>
          </a:xfrm>
          <a:prstGeom prst="rect">
            <a:avLst/>
          </a:prstGeom>
        </p:spPr>
        <p:txBody>
          <a:bodyPr vert="horz" lIns="92099" tIns="46051" rIns="92099" bIns="46051" rtlCol="0"/>
          <a:lstStyle>
            <a:lvl1pPr algn="r">
              <a:defRPr sz="1200"/>
            </a:lvl1pPr>
          </a:lstStyle>
          <a:p>
            <a:fld id="{D89FF672-967F-420C-971B-081309AB1BD4}" type="datetimeFigureOut">
              <a:rPr kumimoji="1" lang="ja-JP" altLang="en-US" smtClean="0"/>
              <a:pPr/>
              <a:t>2021/11/26</a:t>
            </a:fld>
            <a:endParaRPr kumimoji="1" lang="ja-JP" altLang="en-US" dirty="0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2354263" y="744538"/>
            <a:ext cx="2097087" cy="372903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099" tIns="46051" rIns="92099" bIns="46051" rtlCol="0" anchor="ctr"/>
          <a:lstStyle/>
          <a:p>
            <a:endParaRPr lang="ja-JP" altLang="en-US" dirty="0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0562" y="4721194"/>
            <a:ext cx="5444490" cy="4472702"/>
          </a:xfrm>
          <a:prstGeom prst="rect">
            <a:avLst/>
          </a:prstGeom>
        </p:spPr>
        <p:txBody>
          <a:bodyPr vert="horz" lIns="92099" tIns="46051" rIns="92099" bIns="46051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7" y="9440650"/>
            <a:ext cx="2949100" cy="496967"/>
          </a:xfrm>
          <a:prstGeom prst="rect">
            <a:avLst/>
          </a:prstGeom>
        </p:spPr>
        <p:txBody>
          <a:bodyPr vert="horz" lIns="92099" tIns="46051" rIns="92099" bIns="46051" rtlCol="0" anchor="b"/>
          <a:lstStyle>
            <a:lvl1pPr algn="l">
              <a:defRPr sz="1200"/>
            </a:lvl1pPr>
          </a:lstStyle>
          <a:p>
            <a:endParaRPr kumimoji="1" lang="ja-JP" altLang="en-US" dirty="0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54946" y="9440650"/>
            <a:ext cx="2949100" cy="496967"/>
          </a:xfrm>
          <a:prstGeom prst="rect">
            <a:avLst/>
          </a:prstGeom>
        </p:spPr>
        <p:txBody>
          <a:bodyPr vert="horz" lIns="92099" tIns="46051" rIns="92099" bIns="46051" rtlCol="0" anchor="b"/>
          <a:lstStyle>
            <a:lvl1pPr algn="r">
              <a:defRPr sz="1200"/>
            </a:lvl1pPr>
          </a:lstStyle>
          <a:p>
            <a:fld id="{59EAE22E-0FEB-46DB-8B3E-B915DE6CA38E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9477328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2365134" rtl="0" eaLnBrk="1" latinLnBrk="0" hangingPunct="1">
      <a:defRPr kumimoji="1" sz="3100" kern="1200">
        <a:solidFill>
          <a:schemeClr val="tx1"/>
        </a:solidFill>
        <a:latin typeface="+mn-lt"/>
        <a:ea typeface="+mn-ea"/>
        <a:cs typeface="+mn-cs"/>
      </a:defRPr>
    </a:lvl1pPr>
    <a:lvl2pPr marL="1182567" algn="l" defTabSz="2365134" rtl="0" eaLnBrk="1" latinLnBrk="0" hangingPunct="1">
      <a:defRPr kumimoji="1" sz="3100" kern="1200">
        <a:solidFill>
          <a:schemeClr val="tx1"/>
        </a:solidFill>
        <a:latin typeface="+mn-lt"/>
        <a:ea typeface="+mn-ea"/>
        <a:cs typeface="+mn-cs"/>
      </a:defRPr>
    </a:lvl2pPr>
    <a:lvl3pPr marL="2365134" algn="l" defTabSz="2365134" rtl="0" eaLnBrk="1" latinLnBrk="0" hangingPunct="1">
      <a:defRPr kumimoji="1" sz="3100" kern="1200">
        <a:solidFill>
          <a:schemeClr val="tx1"/>
        </a:solidFill>
        <a:latin typeface="+mn-lt"/>
        <a:ea typeface="+mn-ea"/>
        <a:cs typeface="+mn-cs"/>
      </a:defRPr>
    </a:lvl3pPr>
    <a:lvl4pPr marL="3547700" algn="l" defTabSz="2365134" rtl="0" eaLnBrk="1" latinLnBrk="0" hangingPunct="1">
      <a:defRPr kumimoji="1" sz="3100" kern="1200">
        <a:solidFill>
          <a:schemeClr val="tx1"/>
        </a:solidFill>
        <a:latin typeface="+mn-lt"/>
        <a:ea typeface="+mn-ea"/>
        <a:cs typeface="+mn-cs"/>
      </a:defRPr>
    </a:lvl4pPr>
    <a:lvl5pPr marL="4730267" algn="l" defTabSz="2365134" rtl="0" eaLnBrk="1" latinLnBrk="0" hangingPunct="1">
      <a:defRPr kumimoji="1" sz="3100" kern="1200">
        <a:solidFill>
          <a:schemeClr val="tx1"/>
        </a:solidFill>
        <a:latin typeface="+mn-lt"/>
        <a:ea typeface="+mn-ea"/>
        <a:cs typeface="+mn-cs"/>
      </a:defRPr>
    </a:lvl5pPr>
    <a:lvl6pPr marL="5912832" algn="l" defTabSz="2365134" rtl="0" eaLnBrk="1" latinLnBrk="0" hangingPunct="1">
      <a:defRPr kumimoji="1" sz="3100" kern="1200">
        <a:solidFill>
          <a:schemeClr val="tx1"/>
        </a:solidFill>
        <a:latin typeface="+mn-lt"/>
        <a:ea typeface="+mn-ea"/>
        <a:cs typeface="+mn-cs"/>
      </a:defRPr>
    </a:lvl6pPr>
    <a:lvl7pPr marL="7095399" algn="l" defTabSz="2365134" rtl="0" eaLnBrk="1" latinLnBrk="0" hangingPunct="1">
      <a:defRPr kumimoji="1" sz="3100" kern="1200">
        <a:solidFill>
          <a:schemeClr val="tx1"/>
        </a:solidFill>
        <a:latin typeface="+mn-lt"/>
        <a:ea typeface="+mn-ea"/>
        <a:cs typeface="+mn-cs"/>
      </a:defRPr>
    </a:lvl7pPr>
    <a:lvl8pPr marL="8277967" algn="l" defTabSz="2365134" rtl="0" eaLnBrk="1" latinLnBrk="0" hangingPunct="1">
      <a:defRPr kumimoji="1" sz="3100" kern="1200">
        <a:solidFill>
          <a:schemeClr val="tx1"/>
        </a:solidFill>
        <a:latin typeface="+mn-lt"/>
        <a:ea typeface="+mn-ea"/>
        <a:cs typeface="+mn-cs"/>
      </a:defRPr>
    </a:lvl8pPr>
    <a:lvl9pPr marL="9460533" algn="l" defTabSz="2365134" rtl="0" eaLnBrk="1" latinLnBrk="0" hangingPunct="1">
      <a:defRPr kumimoji="1" sz="31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215033" y="8946803"/>
            <a:ext cx="13770372" cy="6173425"/>
          </a:xfrm>
        </p:spPr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2430069" y="16320243"/>
            <a:ext cx="11340307" cy="7360109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105131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21026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31539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420524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52565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630787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73591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841049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 サブタイトル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7B93A-4366-4963-B08F-BDC597821992}" type="datetimeFigureOut">
              <a:rPr kumimoji="1" lang="ja-JP" altLang="en-US" smtClean="0"/>
              <a:pPr/>
              <a:t>2021/11/26</a:t>
            </a:fld>
            <a:endParaRPr kumimoji="1" lang="ja-JP" altLang="en-US" dirty="0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767D0-BDFF-48F5-B379-56B983E36724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7B93A-4366-4963-B08F-BDC597821992}" type="datetimeFigureOut">
              <a:rPr kumimoji="1" lang="ja-JP" altLang="en-US" smtClean="0"/>
              <a:pPr/>
              <a:t>2021/11/26</a:t>
            </a:fld>
            <a:endParaRPr kumimoji="1" lang="ja-JP" altLang="en-US" dirty="0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767D0-BDFF-48F5-B379-56B983E36724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20813064" y="4240064"/>
            <a:ext cx="6457674" cy="90308000"/>
          </a:xfrm>
        </p:spPr>
        <p:txBody>
          <a:bodyPr vert="eaVert"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1434415" y="4240064"/>
            <a:ext cx="19108642" cy="90308000"/>
          </a:xfrm>
        </p:spPr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7B93A-4366-4963-B08F-BDC597821992}" type="datetimeFigureOut">
              <a:rPr kumimoji="1" lang="ja-JP" altLang="en-US" smtClean="0"/>
              <a:pPr/>
              <a:t>2021/11/26</a:t>
            </a:fld>
            <a:endParaRPr kumimoji="1" lang="ja-JP" altLang="en-US" dirty="0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767D0-BDFF-48F5-B379-56B983E36724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7B93A-4366-4963-B08F-BDC597821992}" type="datetimeFigureOut">
              <a:rPr kumimoji="1" lang="ja-JP" altLang="en-US" smtClean="0"/>
              <a:pPr/>
              <a:t>2021/11/26</a:t>
            </a:fld>
            <a:endParaRPr kumimoji="1" lang="ja-JP" altLang="en-US" dirty="0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767D0-BDFF-48F5-B379-56B983E36724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279723" y="18506944"/>
            <a:ext cx="13770372" cy="5720085"/>
          </a:xfrm>
        </p:spPr>
        <p:txBody>
          <a:bodyPr anchor="t"/>
          <a:lstStyle>
            <a:lvl1pPr algn="l">
              <a:defRPr sz="9242" b="1" cap="all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1279723" y="12206852"/>
            <a:ext cx="13770372" cy="6300091"/>
          </a:xfrm>
        </p:spPr>
        <p:txBody>
          <a:bodyPr anchor="b"/>
          <a:lstStyle>
            <a:lvl1pPr marL="0" indent="0">
              <a:buNone/>
              <a:defRPr sz="4621">
                <a:solidFill>
                  <a:schemeClr val="tx1">
                    <a:tint val="75000"/>
                  </a:schemeClr>
                </a:solidFill>
              </a:defRPr>
            </a:lvl1pPr>
            <a:lvl2pPr marL="1051313" indent="0">
              <a:buNone/>
              <a:defRPr sz="4178">
                <a:solidFill>
                  <a:schemeClr val="tx1">
                    <a:tint val="75000"/>
                  </a:schemeClr>
                </a:solidFill>
              </a:defRPr>
            </a:lvl2pPr>
            <a:lvl3pPr marL="2102624" indent="0">
              <a:buNone/>
              <a:defRPr sz="3644">
                <a:solidFill>
                  <a:schemeClr val="tx1">
                    <a:tint val="75000"/>
                  </a:schemeClr>
                </a:solidFill>
              </a:defRPr>
            </a:lvl3pPr>
            <a:lvl4pPr marL="3153937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4pPr>
            <a:lvl5pPr marL="4205249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5pPr>
            <a:lvl6pPr marL="525656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6pPr>
            <a:lvl7pPr marL="6307873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7pPr>
            <a:lvl8pPr marL="7359185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8pPr>
            <a:lvl9pPr marL="8410498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7B93A-4366-4963-B08F-BDC597821992}" type="datetimeFigureOut">
              <a:rPr kumimoji="1" lang="ja-JP" altLang="en-US" smtClean="0"/>
              <a:pPr/>
              <a:t>2021/11/26</a:t>
            </a:fld>
            <a:endParaRPr kumimoji="1" lang="ja-JP" altLang="en-US" dirty="0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767D0-BDFF-48F5-B379-56B983E36724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1434417" y="24693700"/>
            <a:ext cx="12783159" cy="69854364"/>
          </a:xfrm>
        </p:spPr>
        <p:txBody>
          <a:bodyPr/>
          <a:lstStyle>
            <a:lvl1pPr>
              <a:defRPr sz="6399"/>
            </a:lvl1pPr>
            <a:lvl2pPr>
              <a:defRPr sz="5510"/>
            </a:lvl2pPr>
            <a:lvl3pPr>
              <a:defRPr sz="4621"/>
            </a:lvl3pPr>
            <a:lvl4pPr>
              <a:defRPr sz="4178"/>
            </a:lvl4pPr>
            <a:lvl5pPr>
              <a:defRPr sz="4178"/>
            </a:lvl5pPr>
            <a:lvl6pPr>
              <a:defRPr sz="4178"/>
            </a:lvl6pPr>
            <a:lvl7pPr>
              <a:defRPr sz="4178"/>
            </a:lvl7pPr>
            <a:lvl8pPr>
              <a:defRPr sz="4178"/>
            </a:lvl8pPr>
            <a:lvl9pPr>
              <a:defRPr sz="4178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14487581" y="24693700"/>
            <a:ext cx="12783157" cy="69854364"/>
          </a:xfrm>
        </p:spPr>
        <p:txBody>
          <a:bodyPr/>
          <a:lstStyle>
            <a:lvl1pPr>
              <a:defRPr sz="6399"/>
            </a:lvl1pPr>
            <a:lvl2pPr>
              <a:defRPr sz="5510"/>
            </a:lvl2pPr>
            <a:lvl3pPr>
              <a:defRPr sz="4621"/>
            </a:lvl3pPr>
            <a:lvl4pPr>
              <a:defRPr sz="4178"/>
            </a:lvl4pPr>
            <a:lvl5pPr>
              <a:defRPr sz="4178"/>
            </a:lvl5pPr>
            <a:lvl6pPr>
              <a:defRPr sz="4178"/>
            </a:lvl6pPr>
            <a:lvl7pPr>
              <a:defRPr sz="4178"/>
            </a:lvl7pPr>
            <a:lvl8pPr>
              <a:defRPr sz="4178"/>
            </a:lvl8pPr>
            <a:lvl9pPr>
              <a:defRPr sz="4178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7B93A-4366-4963-B08F-BDC597821992}" type="datetimeFigureOut">
              <a:rPr kumimoji="1" lang="ja-JP" altLang="en-US" smtClean="0"/>
              <a:pPr/>
              <a:t>2021/11/26</a:t>
            </a:fld>
            <a:endParaRPr kumimoji="1" lang="ja-JP" altLang="en-US" dirty="0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767D0-BDFF-48F5-B379-56B983E36724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10025" y="1153355"/>
            <a:ext cx="14580395" cy="4800071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810025" y="6446764"/>
            <a:ext cx="7158007" cy="2686704"/>
          </a:xfrm>
        </p:spPr>
        <p:txBody>
          <a:bodyPr anchor="b"/>
          <a:lstStyle>
            <a:lvl1pPr marL="0" indent="0">
              <a:buNone/>
              <a:defRPr sz="5510" b="1"/>
            </a:lvl1pPr>
            <a:lvl2pPr marL="1051313" indent="0">
              <a:buNone/>
              <a:defRPr sz="4621" b="1"/>
            </a:lvl2pPr>
            <a:lvl3pPr marL="2102624" indent="0">
              <a:buNone/>
              <a:defRPr sz="4178" b="1"/>
            </a:lvl3pPr>
            <a:lvl4pPr marL="3153937" indent="0">
              <a:buNone/>
              <a:defRPr sz="3644" b="1"/>
            </a:lvl4pPr>
            <a:lvl5pPr marL="4205249" indent="0">
              <a:buNone/>
              <a:defRPr sz="3644" b="1"/>
            </a:lvl5pPr>
            <a:lvl6pPr marL="5256560" indent="0">
              <a:buNone/>
              <a:defRPr sz="3644" b="1"/>
            </a:lvl6pPr>
            <a:lvl7pPr marL="6307873" indent="0">
              <a:buNone/>
              <a:defRPr sz="3644" b="1"/>
            </a:lvl7pPr>
            <a:lvl8pPr marL="7359185" indent="0">
              <a:buNone/>
              <a:defRPr sz="3644" b="1"/>
            </a:lvl8pPr>
            <a:lvl9pPr marL="8410498" indent="0">
              <a:buNone/>
              <a:defRPr sz="3644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810025" y="9133469"/>
            <a:ext cx="7158007" cy="16593580"/>
          </a:xfrm>
        </p:spPr>
        <p:txBody>
          <a:bodyPr/>
          <a:lstStyle>
            <a:lvl1pPr>
              <a:defRPr sz="5510"/>
            </a:lvl1pPr>
            <a:lvl2pPr>
              <a:defRPr sz="4621"/>
            </a:lvl2pPr>
            <a:lvl3pPr>
              <a:defRPr sz="4178"/>
            </a:lvl3pPr>
            <a:lvl4pPr>
              <a:defRPr sz="3644"/>
            </a:lvl4pPr>
            <a:lvl5pPr>
              <a:defRPr sz="3644"/>
            </a:lvl5pPr>
            <a:lvl6pPr>
              <a:defRPr sz="3644"/>
            </a:lvl6pPr>
            <a:lvl7pPr>
              <a:defRPr sz="3644"/>
            </a:lvl7pPr>
            <a:lvl8pPr>
              <a:defRPr sz="3644"/>
            </a:lvl8pPr>
            <a:lvl9pPr>
              <a:defRPr sz="3644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8229599" y="6446764"/>
            <a:ext cx="7160819" cy="2686704"/>
          </a:xfrm>
        </p:spPr>
        <p:txBody>
          <a:bodyPr anchor="b"/>
          <a:lstStyle>
            <a:lvl1pPr marL="0" indent="0">
              <a:buNone/>
              <a:defRPr sz="5510" b="1"/>
            </a:lvl1pPr>
            <a:lvl2pPr marL="1051313" indent="0">
              <a:buNone/>
              <a:defRPr sz="4621" b="1"/>
            </a:lvl2pPr>
            <a:lvl3pPr marL="2102624" indent="0">
              <a:buNone/>
              <a:defRPr sz="4178" b="1"/>
            </a:lvl3pPr>
            <a:lvl4pPr marL="3153937" indent="0">
              <a:buNone/>
              <a:defRPr sz="3644" b="1"/>
            </a:lvl4pPr>
            <a:lvl5pPr marL="4205249" indent="0">
              <a:buNone/>
              <a:defRPr sz="3644" b="1"/>
            </a:lvl5pPr>
            <a:lvl6pPr marL="5256560" indent="0">
              <a:buNone/>
              <a:defRPr sz="3644" b="1"/>
            </a:lvl6pPr>
            <a:lvl7pPr marL="6307873" indent="0">
              <a:buNone/>
              <a:defRPr sz="3644" b="1"/>
            </a:lvl7pPr>
            <a:lvl8pPr marL="7359185" indent="0">
              <a:buNone/>
              <a:defRPr sz="3644" b="1"/>
            </a:lvl8pPr>
            <a:lvl9pPr marL="8410498" indent="0">
              <a:buNone/>
              <a:defRPr sz="3644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8229599" y="9133469"/>
            <a:ext cx="7160819" cy="16593580"/>
          </a:xfrm>
        </p:spPr>
        <p:txBody>
          <a:bodyPr/>
          <a:lstStyle>
            <a:lvl1pPr>
              <a:defRPr sz="5510"/>
            </a:lvl1pPr>
            <a:lvl2pPr>
              <a:defRPr sz="4621"/>
            </a:lvl2pPr>
            <a:lvl3pPr>
              <a:defRPr sz="4178"/>
            </a:lvl3pPr>
            <a:lvl4pPr>
              <a:defRPr sz="3644"/>
            </a:lvl4pPr>
            <a:lvl5pPr>
              <a:defRPr sz="3644"/>
            </a:lvl5pPr>
            <a:lvl6pPr>
              <a:defRPr sz="3644"/>
            </a:lvl6pPr>
            <a:lvl7pPr>
              <a:defRPr sz="3644"/>
            </a:lvl7pPr>
            <a:lvl8pPr>
              <a:defRPr sz="3644"/>
            </a:lvl8pPr>
            <a:lvl9pPr>
              <a:defRPr sz="3644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7B93A-4366-4963-B08F-BDC597821992}" type="datetimeFigureOut">
              <a:rPr kumimoji="1" lang="ja-JP" altLang="en-US" smtClean="0"/>
              <a:pPr/>
              <a:t>2021/11/26</a:t>
            </a:fld>
            <a:endParaRPr kumimoji="1" lang="ja-JP" altLang="en-US" dirty="0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767D0-BDFF-48F5-B379-56B983E36724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7B93A-4366-4963-B08F-BDC597821992}" type="datetimeFigureOut">
              <a:rPr kumimoji="1" lang="ja-JP" altLang="en-US" smtClean="0"/>
              <a:pPr/>
              <a:t>2021/11/26</a:t>
            </a:fld>
            <a:endParaRPr kumimoji="1" lang="ja-JP" altLang="en-US" dirty="0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767D0-BDFF-48F5-B379-56B983E36724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7B93A-4366-4963-B08F-BDC597821992}" type="datetimeFigureOut">
              <a:rPr kumimoji="1" lang="ja-JP" altLang="en-US" smtClean="0"/>
              <a:pPr/>
              <a:t>2021/11/26</a:t>
            </a:fld>
            <a:endParaRPr kumimoji="1" lang="ja-JP" altLang="en-US" dirty="0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767D0-BDFF-48F5-B379-56B983E36724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10026" y="1146684"/>
            <a:ext cx="5329833" cy="4880072"/>
          </a:xfrm>
        </p:spPr>
        <p:txBody>
          <a:bodyPr anchor="b"/>
          <a:lstStyle>
            <a:lvl1pPr algn="l">
              <a:defRPr sz="4621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6333922" y="1146689"/>
            <a:ext cx="9056495" cy="24580365"/>
          </a:xfrm>
        </p:spPr>
        <p:txBody>
          <a:bodyPr/>
          <a:lstStyle>
            <a:lvl1pPr>
              <a:defRPr sz="7376"/>
            </a:lvl1pPr>
            <a:lvl2pPr>
              <a:defRPr sz="6399"/>
            </a:lvl2pPr>
            <a:lvl3pPr>
              <a:defRPr sz="5510"/>
            </a:lvl3pPr>
            <a:lvl4pPr>
              <a:defRPr sz="4621"/>
            </a:lvl4pPr>
            <a:lvl5pPr>
              <a:defRPr sz="4621"/>
            </a:lvl5pPr>
            <a:lvl6pPr>
              <a:defRPr sz="4621"/>
            </a:lvl6pPr>
            <a:lvl7pPr>
              <a:defRPr sz="4621"/>
            </a:lvl7pPr>
            <a:lvl8pPr>
              <a:defRPr sz="4621"/>
            </a:lvl8pPr>
            <a:lvl9pPr>
              <a:defRPr sz="462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810026" y="6026758"/>
            <a:ext cx="5329833" cy="19700293"/>
          </a:xfrm>
        </p:spPr>
        <p:txBody>
          <a:bodyPr/>
          <a:lstStyle>
            <a:lvl1pPr marL="0" indent="0">
              <a:buNone/>
              <a:defRPr sz="3200"/>
            </a:lvl1pPr>
            <a:lvl2pPr marL="1051313" indent="0">
              <a:buNone/>
              <a:defRPr sz="2755"/>
            </a:lvl2pPr>
            <a:lvl3pPr marL="2102624" indent="0">
              <a:buNone/>
              <a:defRPr sz="2311"/>
            </a:lvl3pPr>
            <a:lvl4pPr marL="3153937" indent="0">
              <a:buNone/>
              <a:defRPr sz="2044"/>
            </a:lvl4pPr>
            <a:lvl5pPr marL="4205249" indent="0">
              <a:buNone/>
              <a:defRPr sz="2044"/>
            </a:lvl5pPr>
            <a:lvl6pPr marL="5256560" indent="0">
              <a:buNone/>
              <a:defRPr sz="2044"/>
            </a:lvl6pPr>
            <a:lvl7pPr marL="6307873" indent="0">
              <a:buNone/>
              <a:defRPr sz="2044"/>
            </a:lvl7pPr>
            <a:lvl8pPr marL="7359185" indent="0">
              <a:buNone/>
              <a:defRPr sz="2044"/>
            </a:lvl8pPr>
            <a:lvl9pPr marL="8410498" indent="0">
              <a:buNone/>
              <a:defRPr sz="2044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7B93A-4366-4963-B08F-BDC597821992}" type="datetimeFigureOut">
              <a:rPr kumimoji="1" lang="ja-JP" altLang="en-US" smtClean="0"/>
              <a:pPr/>
              <a:t>2021/11/26</a:t>
            </a:fld>
            <a:endParaRPr kumimoji="1" lang="ja-JP" altLang="en-US" dirty="0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767D0-BDFF-48F5-B379-56B983E36724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175402" y="20160301"/>
            <a:ext cx="9720263" cy="2380037"/>
          </a:xfrm>
        </p:spPr>
        <p:txBody>
          <a:bodyPr anchor="b"/>
          <a:lstStyle>
            <a:lvl1pPr algn="l">
              <a:defRPr sz="4621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3175402" y="2573371"/>
            <a:ext cx="9720263" cy="17280255"/>
          </a:xfrm>
        </p:spPr>
        <p:txBody>
          <a:bodyPr/>
          <a:lstStyle>
            <a:lvl1pPr marL="0" indent="0">
              <a:buNone/>
              <a:defRPr sz="7376"/>
            </a:lvl1pPr>
            <a:lvl2pPr marL="1051313" indent="0">
              <a:buNone/>
              <a:defRPr sz="6399"/>
            </a:lvl2pPr>
            <a:lvl3pPr marL="2102624" indent="0">
              <a:buNone/>
              <a:defRPr sz="5510"/>
            </a:lvl3pPr>
            <a:lvl4pPr marL="3153937" indent="0">
              <a:buNone/>
              <a:defRPr sz="4621"/>
            </a:lvl4pPr>
            <a:lvl5pPr marL="4205249" indent="0">
              <a:buNone/>
              <a:defRPr sz="4621"/>
            </a:lvl5pPr>
            <a:lvl6pPr marL="5256560" indent="0">
              <a:buNone/>
              <a:defRPr sz="4621"/>
            </a:lvl6pPr>
            <a:lvl7pPr marL="6307873" indent="0">
              <a:buNone/>
              <a:defRPr sz="4621"/>
            </a:lvl7pPr>
            <a:lvl8pPr marL="7359185" indent="0">
              <a:buNone/>
              <a:defRPr sz="4621"/>
            </a:lvl8pPr>
            <a:lvl9pPr marL="8410498" indent="0">
              <a:buNone/>
              <a:defRPr sz="4621"/>
            </a:lvl9pPr>
          </a:lstStyle>
          <a:p>
            <a:endParaRPr kumimoji="1" lang="ja-JP" altLang="en-US" dirty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175402" y="22540335"/>
            <a:ext cx="9720263" cy="3380048"/>
          </a:xfrm>
        </p:spPr>
        <p:txBody>
          <a:bodyPr/>
          <a:lstStyle>
            <a:lvl1pPr marL="0" indent="0">
              <a:buNone/>
              <a:defRPr sz="3200"/>
            </a:lvl1pPr>
            <a:lvl2pPr marL="1051313" indent="0">
              <a:buNone/>
              <a:defRPr sz="2755"/>
            </a:lvl2pPr>
            <a:lvl3pPr marL="2102624" indent="0">
              <a:buNone/>
              <a:defRPr sz="2311"/>
            </a:lvl3pPr>
            <a:lvl4pPr marL="3153937" indent="0">
              <a:buNone/>
              <a:defRPr sz="2044"/>
            </a:lvl4pPr>
            <a:lvl5pPr marL="4205249" indent="0">
              <a:buNone/>
              <a:defRPr sz="2044"/>
            </a:lvl5pPr>
            <a:lvl6pPr marL="5256560" indent="0">
              <a:buNone/>
              <a:defRPr sz="2044"/>
            </a:lvl6pPr>
            <a:lvl7pPr marL="6307873" indent="0">
              <a:buNone/>
              <a:defRPr sz="2044"/>
            </a:lvl7pPr>
            <a:lvl8pPr marL="7359185" indent="0">
              <a:buNone/>
              <a:defRPr sz="2044"/>
            </a:lvl8pPr>
            <a:lvl9pPr marL="8410498" indent="0">
              <a:buNone/>
              <a:defRPr sz="2044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7B93A-4366-4963-B08F-BDC597821992}" type="datetimeFigureOut">
              <a:rPr kumimoji="1" lang="ja-JP" altLang="en-US" smtClean="0"/>
              <a:pPr/>
              <a:t>2021/11/26</a:t>
            </a:fld>
            <a:endParaRPr kumimoji="1" lang="ja-JP" altLang="en-US" dirty="0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767D0-BDFF-48F5-B379-56B983E36724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810025" y="1153355"/>
            <a:ext cx="14580395" cy="4800071"/>
          </a:xfrm>
          <a:prstGeom prst="rect">
            <a:avLst/>
          </a:prstGeom>
        </p:spPr>
        <p:txBody>
          <a:bodyPr vert="horz" lIns="236601" tIns="118301" rIns="236601" bIns="118301" rtlCol="0" anchor="ctr">
            <a:normAutofit/>
          </a:bodyPr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810025" y="6720105"/>
            <a:ext cx="14580395" cy="19006949"/>
          </a:xfrm>
          <a:prstGeom prst="rect">
            <a:avLst/>
          </a:prstGeom>
        </p:spPr>
        <p:txBody>
          <a:bodyPr vert="horz" lIns="236601" tIns="118301" rIns="236601" bIns="118301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810025" y="26693729"/>
            <a:ext cx="3780103" cy="1533356"/>
          </a:xfrm>
          <a:prstGeom prst="rect">
            <a:avLst/>
          </a:prstGeom>
        </p:spPr>
        <p:txBody>
          <a:bodyPr vert="horz" lIns="236601" tIns="118301" rIns="236601" bIns="118301" rtlCol="0" anchor="ctr"/>
          <a:lstStyle>
            <a:lvl1pPr algn="l">
              <a:defRPr sz="275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97B93A-4366-4963-B08F-BDC597821992}" type="datetimeFigureOut">
              <a:rPr kumimoji="1" lang="ja-JP" altLang="en-US" smtClean="0"/>
              <a:pPr/>
              <a:t>2021/11/26</a:t>
            </a:fld>
            <a:endParaRPr kumimoji="1" lang="ja-JP" altLang="en-US" dirty="0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5535150" y="26693729"/>
            <a:ext cx="5130138" cy="1533356"/>
          </a:xfrm>
          <a:prstGeom prst="rect">
            <a:avLst/>
          </a:prstGeom>
        </p:spPr>
        <p:txBody>
          <a:bodyPr vert="horz" lIns="236601" tIns="118301" rIns="236601" bIns="118301" rtlCol="0" anchor="ctr"/>
          <a:lstStyle>
            <a:lvl1pPr algn="ctr">
              <a:defRPr sz="275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 dirty="0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11610317" y="26693729"/>
            <a:ext cx="3780103" cy="1533356"/>
          </a:xfrm>
          <a:prstGeom prst="rect">
            <a:avLst/>
          </a:prstGeom>
        </p:spPr>
        <p:txBody>
          <a:bodyPr vert="horz" lIns="236601" tIns="118301" rIns="236601" bIns="118301" rtlCol="0" anchor="ctr"/>
          <a:lstStyle>
            <a:lvl1pPr algn="r">
              <a:defRPr sz="275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3767D0-BDFF-48F5-B379-56B983E36724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2102624" rtl="0" eaLnBrk="1" latinLnBrk="0" hangingPunct="1">
        <a:spcBef>
          <a:spcPct val="0"/>
        </a:spcBef>
        <a:buNone/>
        <a:defRPr kumimoji="1" sz="1013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788483" indent="-788483" algn="l" defTabSz="2102624" rtl="0" eaLnBrk="1" latinLnBrk="0" hangingPunct="1">
        <a:spcBef>
          <a:spcPct val="20000"/>
        </a:spcBef>
        <a:buFont typeface="Arial" pitchFamily="34" charset="0"/>
        <a:buChar char="•"/>
        <a:defRPr kumimoji="1" sz="7376" kern="1200">
          <a:solidFill>
            <a:schemeClr val="tx1"/>
          </a:solidFill>
          <a:latin typeface="+mn-lt"/>
          <a:ea typeface="+mn-ea"/>
          <a:cs typeface="+mn-cs"/>
        </a:defRPr>
      </a:lvl1pPr>
      <a:lvl2pPr marL="1708383" indent="-657070" algn="l" defTabSz="2102624" rtl="0" eaLnBrk="1" latinLnBrk="0" hangingPunct="1">
        <a:spcBef>
          <a:spcPct val="20000"/>
        </a:spcBef>
        <a:buFont typeface="Arial" pitchFamily="34" charset="0"/>
        <a:buChar char="–"/>
        <a:defRPr kumimoji="1" sz="6399" kern="1200">
          <a:solidFill>
            <a:schemeClr val="tx1"/>
          </a:solidFill>
          <a:latin typeface="+mn-lt"/>
          <a:ea typeface="+mn-ea"/>
          <a:cs typeface="+mn-cs"/>
        </a:defRPr>
      </a:lvl2pPr>
      <a:lvl3pPr marL="2628281" indent="-525657" algn="l" defTabSz="2102624" rtl="0" eaLnBrk="1" latinLnBrk="0" hangingPunct="1">
        <a:spcBef>
          <a:spcPct val="20000"/>
        </a:spcBef>
        <a:buFont typeface="Arial" pitchFamily="34" charset="0"/>
        <a:buChar char="•"/>
        <a:defRPr kumimoji="1" sz="5510" kern="1200">
          <a:solidFill>
            <a:schemeClr val="tx1"/>
          </a:solidFill>
          <a:latin typeface="+mn-lt"/>
          <a:ea typeface="+mn-ea"/>
          <a:cs typeface="+mn-cs"/>
        </a:defRPr>
      </a:lvl3pPr>
      <a:lvl4pPr marL="3679593" indent="-525657" algn="l" defTabSz="2102624" rtl="0" eaLnBrk="1" latinLnBrk="0" hangingPunct="1">
        <a:spcBef>
          <a:spcPct val="20000"/>
        </a:spcBef>
        <a:buFont typeface="Arial" pitchFamily="34" charset="0"/>
        <a:buChar char="–"/>
        <a:defRPr kumimoji="1" sz="4621" kern="1200">
          <a:solidFill>
            <a:schemeClr val="tx1"/>
          </a:solidFill>
          <a:latin typeface="+mn-lt"/>
          <a:ea typeface="+mn-ea"/>
          <a:cs typeface="+mn-cs"/>
        </a:defRPr>
      </a:lvl4pPr>
      <a:lvl5pPr marL="4730906" indent="-525657" algn="l" defTabSz="2102624" rtl="0" eaLnBrk="1" latinLnBrk="0" hangingPunct="1">
        <a:spcBef>
          <a:spcPct val="20000"/>
        </a:spcBef>
        <a:buFont typeface="Arial" pitchFamily="34" charset="0"/>
        <a:buChar char="»"/>
        <a:defRPr kumimoji="1" sz="4621" kern="1200">
          <a:solidFill>
            <a:schemeClr val="tx1"/>
          </a:solidFill>
          <a:latin typeface="+mn-lt"/>
          <a:ea typeface="+mn-ea"/>
          <a:cs typeface="+mn-cs"/>
        </a:defRPr>
      </a:lvl5pPr>
      <a:lvl6pPr marL="5782217" indent="-525657" algn="l" defTabSz="2102624" rtl="0" eaLnBrk="1" latinLnBrk="0" hangingPunct="1">
        <a:spcBef>
          <a:spcPct val="20000"/>
        </a:spcBef>
        <a:buFont typeface="Arial" pitchFamily="34" charset="0"/>
        <a:buChar char="•"/>
        <a:defRPr kumimoji="1" sz="4621" kern="1200">
          <a:solidFill>
            <a:schemeClr val="tx1"/>
          </a:solidFill>
          <a:latin typeface="+mn-lt"/>
          <a:ea typeface="+mn-ea"/>
          <a:cs typeface="+mn-cs"/>
        </a:defRPr>
      </a:lvl6pPr>
      <a:lvl7pPr marL="6833529" indent="-525657" algn="l" defTabSz="2102624" rtl="0" eaLnBrk="1" latinLnBrk="0" hangingPunct="1">
        <a:spcBef>
          <a:spcPct val="20000"/>
        </a:spcBef>
        <a:buFont typeface="Arial" pitchFamily="34" charset="0"/>
        <a:buChar char="•"/>
        <a:defRPr kumimoji="1" sz="4621" kern="1200">
          <a:solidFill>
            <a:schemeClr val="tx1"/>
          </a:solidFill>
          <a:latin typeface="+mn-lt"/>
          <a:ea typeface="+mn-ea"/>
          <a:cs typeface="+mn-cs"/>
        </a:defRPr>
      </a:lvl7pPr>
      <a:lvl8pPr marL="7884842" indent="-525657" algn="l" defTabSz="2102624" rtl="0" eaLnBrk="1" latinLnBrk="0" hangingPunct="1">
        <a:spcBef>
          <a:spcPct val="20000"/>
        </a:spcBef>
        <a:buFont typeface="Arial" pitchFamily="34" charset="0"/>
        <a:buChar char="•"/>
        <a:defRPr kumimoji="1" sz="4621" kern="1200">
          <a:solidFill>
            <a:schemeClr val="tx1"/>
          </a:solidFill>
          <a:latin typeface="+mn-lt"/>
          <a:ea typeface="+mn-ea"/>
          <a:cs typeface="+mn-cs"/>
        </a:defRPr>
      </a:lvl8pPr>
      <a:lvl9pPr marL="8936153" indent="-525657" algn="l" defTabSz="2102624" rtl="0" eaLnBrk="1" latinLnBrk="0" hangingPunct="1">
        <a:spcBef>
          <a:spcPct val="20000"/>
        </a:spcBef>
        <a:buFont typeface="Arial" pitchFamily="34" charset="0"/>
        <a:buChar char="•"/>
        <a:defRPr kumimoji="1" sz="462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2102624" rtl="0" eaLnBrk="1" latinLnBrk="0" hangingPunct="1">
        <a:defRPr kumimoji="1" sz="4178" kern="1200">
          <a:solidFill>
            <a:schemeClr val="tx1"/>
          </a:solidFill>
          <a:latin typeface="+mn-lt"/>
          <a:ea typeface="+mn-ea"/>
          <a:cs typeface="+mn-cs"/>
        </a:defRPr>
      </a:lvl1pPr>
      <a:lvl2pPr marL="1051313" algn="l" defTabSz="2102624" rtl="0" eaLnBrk="1" latinLnBrk="0" hangingPunct="1">
        <a:defRPr kumimoji="1" sz="4178" kern="1200">
          <a:solidFill>
            <a:schemeClr val="tx1"/>
          </a:solidFill>
          <a:latin typeface="+mn-lt"/>
          <a:ea typeface="+mn-ea"/>
          <a:cs typeface="+mn-cs"/>
        </a:defRPr>
      </a:lvl2pPr>
      <a:lvl3pPr marL="2102624" algn="l" defTabSz="2102624" rtl="0" eaLnBrk="1" latinLnBrk="0" hangingPunct="1">
        <a:defRPr kumimoji="1" sz="4178" kern="1200">
          <a:solidFill>
            <a:schemeClr val="tx1"/>
          </a:solidFill>
          <a:latin typeface="+mn-lt"/>
          <a:ea typeface="+mn-ea"/>
          <a:cs typeface="+mn-cs"/>
        </a:defRPr>
      </a:lvl3pPr>
      <a:lvl4pPr marL="3153937" algn="l" defTabSz="2102624" rtl="0" eaLnBrk="1" latinLnBrk="0" hangingPunct="1">
        <a:defRPr kumimoji="1" sz="4178" kern="1200">
          <a:solidFill>
            <a:schemeClr val="tx1"/>
          </a:solidFill>
          <a:latin typeface="+mn-lt"/>
          <a:ea typeface="+mn-ea"/>
          <a:cs typeface="+mn-cs"/>
        </a:defRPr>
      </a:lvl4pPr>
      <a:lvl5pPr marL="4205249" algn="l" defTabSz="2102624" rtl="0" eaLnBrk="1" latinLnBrk="0" hangingPunct="1">
        <a:defRPr kumimoji="1" sz="4178" kern="1200">
          <a:solidFill>
            <a:schemeClr val="tx1"/>
          </a:solidFill>
          <a:latin typeface="+mn-lt"/>
          <a:ea typeface="+mn-ea"/>
          <a:cs typeface="+mn-cs"/>
        </a:defRPr>
      </a:lvl5pPr>
      <a:lvl6pPr marL="5256560" algn="l" defTabSz="2102624" rtl="0" eaLnBrk="1" latinLnBrk="0" hangingPunct="1">
        <a:defRPr kumimoji="1" sz="4178" kern="1200">
          <a:solidFill>
            <a:schemeClr val="tx1"/>
          </a:solidFill>
          <a:latin typeface="+mn-lt"/>
          <a:ea typeface="+mn-ea"/>
          <a:cs typeface="+mn-cs"/>
        </a:defRPr>
      </a:lvl6pPr>
      <a:lvl7pPr marL="6307873" algn="l" defTabSz="2102624" rtl="0" eaLnBrk="1" latinLnBrk="0" hangingPunct="1">
        <a:defRPr kumimoji="1" sz="4178" kern="1200">
          <a:solidFill>
            <a:schemeClr val="tx1"/>
          </a:solidFill>
          <a:latin typeface="+mn-lt"/>
          <a:ea typeface="+mn-ea"/>
          <a:cs typeface="+mn-cs"/>
        </a:defRPr>
      </a:lvl7pPr>
      <a:lvl8pPr marL="7359185" algn="l" defTabSz="2102624" rtl="0" eaLnBrk="1" latinLnBrk="0" hangingPunct="1">
        <a:defRPr kumimoji="1" sz="4178" kern="1200">
          <a:solidFill>
            <a:schemeClr val="tx1"/>
          </a:solidFill>
          <a:latin typeface="+mn-lt"/>
          <a:ea typeface="+mn-ea"/>
          <a:cs typeface="+mn-cs"/>
        </a:defRPr>
      </a:lvl8pPr>
      <a:lvl9pPr marL="8410498" algn="l" defTabSz="2102624" rtl="0" eaLnBrk="1" latinLnBrk="0" hangingPunct="1">
        <a:defRPr kumimoji="1" sz="417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2">
            <a:extLst>
              <a:ext uri="{FF2B5EF4-FFF2-40B4-BE49-F238E27FC236}">
                <a16:creationId xmlns:a16="http://schemas.microsoft.com/office/drawing/2014/main" id="{F28691A6-242F-4AB6-B67C-5AD011C1B33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01709306"/>
              </p:ext>
            </p:extLst>
          </p:nvPr>
        </p:nvGraphicFramePr>
        <p:xfrm>
          <a:off x="2520219" y="10080212"/>
          <a:ext cx="11488718" cy="43200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719176">
                  <a:extLst>
                    <a:ext uri="{9D8B030D-6E8A-4147-A177-3AD203B41FA5}">
                      <a16:colId xmlns:a16="http://schemas.microsoft.com/office/drawing/2014/main" val="680953890"/>
                    </a:ext>
                  </a:extLst>
                </a:gridCol>
                <a:gridCol w="4909542">
                  <a:extLst>
                    <a:ext uri="{9D8B030D-6E8A-4147-A177-3AD203B41FA5}">
                      <a16:colId xmlns:a16="http://schemas.microsoft.com/office/drawing/2014/main" val="2860505301"/>
                    </a:ext>
                  </a:extLst>
                </a:gridCol>
                <a:gridCol w="4860000">
                  <a:extLst>
                    <a:ext uri="{9D8B030D-6E8A-4147-A177-3AD203B41FA5}">
                      <a16:colId xmlns:a16="http://schemas.microsoft.com/office/drawing/2014/main" val="191701814"/>
                    </a:ext>
                  </a:extLst>
                </a:gridCol>
              </a:tblGrid>
              <a:tr h="480000">
                <a:tc>
                  <a:txBody>
                    <a:bodyPr/>
                    <a:lstStyle/>
                    <a:p>
                      <a:r>
                        <a:rPr lang="en-US" altLang="ja-JP" sz="20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Gene</a:t>
                      </a:r>
                      <a:endParaRPr kumimoji="1" lang="ja-JP" altLang="en-US" sz="2000" i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210262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2000" b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Forward (5'-3')</a:t>
                      </a:r>
                      <a:endParaRPr kumimoji="1" lang="ja-JP" altLang="en-US" sz="2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2000" b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 (5'-3')</a:t>
                      </a:r>
                      <a:endParaRPr kumimoji="1" lang="ja-JP" altLang="en-US" sz="2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981601783"/>
                  </a:ext>
                </a:extLst>
              </a:tr>
              <a:tr h="480000">
                <a:tc>
                  <a:txBody>
                    <a:bodyPr/>
                    <a:lstStyle/>
                    <a:p>
                      <a:r>
                        <a:rPr lang="en-US" altLang="ja-JP" sz="20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Sp7</a:t>
                      </a:r>
                      <a:endParaRPr kumimoji="1" lang="ja-JP" altLang="en-US" sz="20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2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GCCTTTGCCAGTGCCTA</a:t>
                      </a:r>
                      <a:endParaRPr kumimoji="1" lang="ja-JP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2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CAGATGGAAGCTGTGAAGA</a:t>
                      </a:r>
                      <a:endParaRPr kumimoji="1" lang="ja-JP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18439953"/>
                  </a:ext>
                </a:extLst>
              </a:tr>
              <a:tr h="480000">
                <a:tc>
                  <a:txBody>
                    <a:bodyPr/>
                    <a:lstStyle/>
                    <a:p>
                      <a:r>
                        <a:rPr kumimoji="1" lang="en-US" altLang="ja-JP" sz="20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Runx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CCACCACGCCGCTGTCT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CAGTGAGGGATGAAATGCT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89070268"/>
                  </a:ext>
                </a:extLst>
              </a:tr>
              <a:tr h="480000">
                <a:tc>
                  <a:txBody>
                    <a:bodyPr/>
                    <a:lstStyle/>
                    <a:p>
                      <a:r>
                        <a:rPr kumimoji="1" lang="en-US" altLang="ja-JP" sz="20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ol1a1</a:t>
                      </a:r>
                      <a:endParaRPr kumimoji="1" lang="ja-JP" altLang="en-US" sz="20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CAGTGCAATTGTGTTGCTGAAAG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GATACCAAACTGGGCGTGCTG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55297558"/>
                  </a:ext>
                </a:extLst>
              </a:tr>
              <a:tr h="480000">
                <a:tc>
                  <a:txBody>
                    <a:bodyPr/>
                    <a:lstStyle/>
                    <a:p>
                      <a:r>
                        <a:rPr kumimoji="1" lang="en-US" altLang="ja-JP" sz="20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ol2a1</a:t>
                      </a:r>
                      <a:endParaRPr kumimoji="1" lang="ja-JP" altLang="en-US" sz="20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ATCCAGGGCTCCAATGATGTA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TGTCCATGGGTGCGATGTC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35639674"/>
                  </a:ext>
                </a:extLst>
              </a:tr>
              <a:tr h="480000">
                <a:tc>
                  <a:txBody>
                    <a:bodyPr/>
                    <a:lstStyle/>
                    <a:p>
                      <a:r>
                        <a:rPr kumimoji="1" lang="en-US" altLang="ja-JP" sz="20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ol10a1</a:t>
                      </a:r>
                      <a:endParaRPr kumimoji="1" lang="ja-JP" altLang="en-US" sz="20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AATACTTCATCCCATACGCCATAA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GCTGATATTCCTGGTGGTCCTG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36853601"/>
                  </a:ext>
                </a:extLst>
              </a:tr>
              <a:tr h="480000">
                <a:tc>
                  <a:txBody>
                    <a:bodyPr/>
                    <a:lstStyle/>
                    <a:p>
                      <a:r>
                        <a:rPr kumimoji="1" lang="en-US" altLang="ja-JP" sz="20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kumimoji="1" lang="en-US" altLang="ja-JP" sz="200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an</a:t>
                      </a:r>
                      <a:endParaRPr kumimoji="1" lang="ja-JP" altLang="en-US" sz="20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GTGGATCGGTCTGAATGACAGG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GAAGTTGTCAGGCTGGTTTGGA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77477672"/>
                  </a:ext>
                </a:extLst>
              </a:tr>
              <a:tr h="480000">
                <a:tc>
                  <a:txBody>
                    <a:bodyPr/>
                    <a:lstStyle/>
                    <a:p>
                      <a:r>
                        <a:rPr kumimoji="1" lang="en-US" altLang="ja-JP" sz="20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Sox9</a:t>
                      </a:r>
                      <a:endParaRPr kumimoji="1" lang="ja-JP" altLang="en-US" sz="20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AGGAAGCTGGCAGACCAGTA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AGGGTCTCTTCTCGCTCTCGTT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49391875"/>
                  </a:ext>
                </a:extLst>
              </a:tr>
              <a:tr h="480000">
                <a:tc>
                  <a:txBody>
                    <a:bodyPr/>
                    <a:lstStyle/>
                    <a:p>
                      <a:r>
                        <a:rPr kumimoji="1" lang="en-US" altLang="ja-JP" sz="20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kumimoji="1" lang="en-US" altLang="ja-JP" sz="200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pdh</a:t>
                      </a:r>
                      <a:endParaRPr kumimoji="1" lang="ja-JP" altLang="en-US" sz="20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GTGTCCGTCGTGGATCTGA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TGCTGTTGAAGTCGCAGGAG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92137036"/>
                  </a:ext>
                </a:extLst>
              </a:tr>
            </a:tbl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6F5275CA-5890-A648-BAC1-1AA6CF78922B}"/>
              </a:ext>
            </a:extLst>
          </p:cNvPr>
          <p:cNvSpPr txBox="1"/>
          <p:nvPr/>
        </p:nvSpPr>
        <p:spPr>
          <a:xfrm>
            <a:off x="2895063" y="9517172"/>
            <a:ext cx="1073903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dirty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kumimoji="1" lang="ja-JP" altLang="en-US" sz="2800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kumimoji="1" lang="en-US" altLang="ja-JP" sz="2800" dirty="0">
                <a:latin typeface="Arial" panose="020B0604020202020204" pitchFamily="34" charset="0"/>
                <a:cs typeface="Arial" panose="020B0604020202020204" pitchFamily="34" charset="0"/>
              </a:rPr>
              <a:t>Table 1. The primer sequences used for each gene</a:t>
            </a:r>
            <a:endParaRPr kumimoji="1"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869453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15</TotalTime>
  <Words>72</Words>
  <Application>Microsoft Macintosh PowerPoint</Application>
  <PresentationFormat>ユーザー設定</PresentationFormat>
  <Paragraphs>2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テーマ</vt:lpstr>
      <vt:lpstr>PowerPoint プレゼンテーション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evelopment of the mouse lateral pterigoid  muscle in the embryonal period M Yamamoto1、A Kisi1、 A kikuchi1、 S Abe1、2、Y Ide1  1Department of Anatomy, Tokyo Dental College, Chiba, Japan   2Oral Health Science Center hrc8, Tokyo Dental College, Chiba, Japan</dc:title>
  <dc:creator>anatomy256</dc:creator>
  <cp:lastModifiedBy>朗 山口</cp:lastModifiedBy>
  <cp:revision>852</cp:revision>
  <cp:lastPrinted>2021-11-22T00:45:35Z</cp:lastPrinted>
  <dcterms:created xsi:type="dcterms:W3CDTF">2011-09-07T12:11:16Z</dcterms:created>
  <dcterms:modified xsi:type="dcterms:W3CDTF">2021-11-26T04:27:01Z</dcterms:modified>
</cp:coreProperties>
</file>